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66" d="100"/>
          <a:sy n="66" d="100"/>
        </p:scale>
        <p:origin x="1253" y="34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omen Škrab" userId="d024ea2c96fe2869" providerId="LiveId" clId="{E91B0A70-C32B-48E1-BE32-7F51CA894F08}"/>
    <pc:docChg chg="modSld">
      <pc:chgData name="Domen Škrab" userId="d024ea2c96fe2869" providerId="LiveId" clId="{E91B0A70-C32B-48E1-BE32-7F51CA894F08}" dt="2021-11-17T19:43:03.582" v="5" actId="1076"/>
      <pc:docMkLst>
        <pc:docMk/>
      </pc:docMkLst>
      <pc:sldChg chg="modSp mod">
        <pc:chgData name="Domen Škrab" userId="d024ea2c96fe2869" providerId="LiveId" clId="{E91B0A70-C32B-48E1-BE32-7F51CA894F08}" dt="2021-11-17T19:43:03.582" v="5" actId="1076"/>
        <pc:sldMkLst>
          <pc:docMk/>
          <pc:sldMk cId="3406524665" sldId="258"/>
        </pc:sldMkLst>
        <pc:spChg chg="mod">
          <ac:chgData name="Domen Škrab" userId="d024ea2c96fe2869" providerId="LiveId" clId="{E91B0A70-C32B-48E1-BE32-7F51CA894F08}" dt="2021-11-17T19:43:03.582" v="5" actId="1076"/>
          <ac:spMkLst>
            <pc:docMk/>
            <pc:sldMk cId="3406524665" sldId="258"/>
            <ac:spMk id="6" creationId="{6754E768-8924-4C58-9E7C-42B2C7C0AE83}"/>
          </ac:spMkLst>
        </pc:spChg>
        <pc:picChg chg="mod modCrop">
          <ac:chgData name="Domen Škrab" userId="d024ea2c96fe2869" providerId="LiveId" clId="{E91B0A70-C32B-48E1-BE32-7F51CA894F08}" dt="2021-11-17T19:42:32.545" v="1" actId="1076"/>
          <ac:picMkLst>
            <pc:docMk/>
            <pc:sldMk cId="3406524665" sldId="258"/>
            <ac:picMk id="3" creationId="{50C66FAA-76A0-4245-BE71-ADE7AC659373}"/>
          </ac:picMkLst>
        </pc:picChg>
        <pc:picChg chg="mod modCrop">
          <ac:chgData name="Domen Škrab" userId="d024ea2c96fe2869" providerId="LiveId" clId="{E91B0A70-C32B-48E1-BE32-7F51CA894F08}" dt="2021-11-17T19:42:46.991" v="3" actId="1076"/>
          <ac:picMkLst>
            <pc:docMk/>
            <pc:sldMk cId="3406524665" sldId="258"/>
            <ac:picMk id="5" creationId="{BA9FCC6F-870C-4BAF-95B6-354F168E7E02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38EC36-CB59-4B85-A53B-E8660803BA8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E31862E-2085-440E-BEC6-AD79CB6D87B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2774E1-F09E-4E35-A33B-69F530612A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327B2-13A3-4B53-AA10-EE169C2AD847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5D76D5-3134-47CB-999A-7A14D0707B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A5FF18-A6C1-4AAC-B745-D0A7E66DDD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007F1-BBBF-4A82-9634-86D672C69F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4493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5145A5-20A1-405F-94F3-77E8FEB42C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3FC9510-A616-4212-9099-ECEDCD7DA8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26F968-F936-4424-83E5-42B6D9CD96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327B2-13A3-4B53-AA10-EE169C2AD847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668E79-B3CB-4E37-8F6A-C3567D5B18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2ADA13-965D-4FD0-A9EB-366AD52989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007F1-BBBF-4A82-9634-86D672C69F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71151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5DEB0AA-DDD2-4A08-ABC6-EEE0B02E811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36DE71D-00C9-4769-9C4B-7B032211AE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27F6F1-771F-4743-B8CA-39CC786D78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327B2-13A3-4B53-AA10-EE169C2AD847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DC4813-EF04-4F98-BC58-20C45F0AAF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53A955-CCBF-4FAF-831C-34AFD68AF6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007F1-BBBF-4A82-9634-86D672C69F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84738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B9E85A-4839-4A6A-BDEF-2F6AA3199B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3AF1A2-8635-4D60-9207-1648BECA2BA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A6BDB1-75AA-4342-A8D8-71BE2309EF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327B2-13A3-4B53-AA10-EE169C2AD847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FDC531-2609-47CE-A0F6-4459AEB5C2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5502CA-2F71-452A-BEAF-7DEB0E4E0C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007F1-BBBF-4A82-9634-86D672C69F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46067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FC592D-A4F0-4140-99B4-C3D4DDA0B7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6374018-7340-4421-B166-CFE41D87FF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D2E88B-E25E-427D-ABF0-78AAC8F973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327B2-13A3-4B53-AA10-EE169C2AD847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42AAD9-1C54-40B7-8310-6389FAE6E7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5FA5E3-B0E0-4A73-A121-EAB45258CF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007F1-BBBF-4A82-9634-86D672C69F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22654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A6A48B-1654-437D-9FB0-90A4DCAF8F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9CC921-F7E7-4DA5-8C35-A76079A0901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218A64B-2045-4586-902E-67A7E785D8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22E8C7-7971-4BE1-972A-48B2734C4C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327B2-13A3-4B53-AA10-EE169C2AD847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E0A7E4-0B9C-4CF8-941A-A49DCACB07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AD63DC7-B55E-41A7-A72A-613DA54D61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007F1-BBBF-4A82-9634-86D672C69F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7761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3E5DAA-FB8B-491E-ABCE-B73365F563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E1DD3F1-6BF0-46CE-88A9-FDB5C7758F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40481F-8286-4706-826E-3485BF15CA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8897201-2BF5-4B95-B460-97A39DBCA9A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CBBDF5C-ABB5-4E96-83F3-C4FC7FE3036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0710FCC-DF3D-47B2-9F21-56925D7771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327B2-13A3-4B53-AA10-EE169C2AD847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005DAA5-62D0-4D77-9824-9181C05289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AACCD1B-7268-4A6F-8A7F-7F82346F43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007F1-BBBF-4A82-9634-86D672C69F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67929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14E1BF-2111-485F-B058-3E00124EE0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F9FEB6F-9E72-4A49-AC98-8C80349280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327B2-13A3-4B53-AA10-EE169C2AD847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16330A1-1E87-4542-98EC-F49FEADEEA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6B8A591-F484-4EF1-8052-DFF9AD525F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007F1-BBBF-4A82-9634-86D672C69F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33677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08D6D2E-9E7B-425B-876D-D6E7F4819E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327B2-13A3-4B53-AA10-EE169C2AD847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95391AC-9432-409E-A062-C77F274C83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BB7C65E-3547-4CC5-817C-07277F2070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007F1-BBBF-4A82-9634-86D672C69F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16071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3A6ABE-EBAA-4784-9A13-1D7D786E8D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610F21-5C8D-42D1-A00F-D113659D41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8CD4789-5478-452D-B256-342D4D402E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508E3D-EB28-4550-9983-1374B2C5A9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327B2-13A3-4B53-AA10-EE169C2AD847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2B9AA0-814B-4AC3-B5F0-BDC2A74F6A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A2FCD2-D8BE-4DC7-8156-D1D18B8F1E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007F1-BBBF-4A82-9634-86D672C69F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904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674567-439F-48D4-A91D-1F6E1E3360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BEC4880-4C67-4B87-9742-BFD12B345D0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BA4577B-41E9-41AD-B81E-CB9962D118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130160D-3F05-4302-8263-17A85B787E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327B2-13A3-4B53-AA10-EE169C2AD847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FA940E4-FC21-44B7-A236-11577D6D54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65392DE-3F0C-4B02-94A9-F06CA1754F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007F1-BBBF-4A82-9634-86D672C69F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71622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F033391-009C-49FE-85FA-9120030DC3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1283505-2969-464B-B3F9-DE1E239B34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C19B3F-4C96-4061-9624-613E7495D59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D327B2-13A3-4B53-AA10-EE169C2AD847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C1F02E-F8F2-4A3B-AB15-06F75B8C694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7355B1-B7C8-44E4-8A9C-DDF6E118DBB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0007F1-BBBF-4A82-9634-86D672C69F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2580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, histogram&#10;&#10;Description automatically generated">
            <a:extLst>
              <a:ext uri="{FF2B5EF4-FFF2-40B4-BE49-F238E27FC236}">
                <a16:creationId xmlns:a16="http://schemas.microsoft.com/office/drawing/2014/main" id="{CC282CBD-043C-457A-AE80-7DC3CE16955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727" y="1706731"/>
            <a:ext cx="12034547" cy="344453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FC08124-3224-40B6-9297-01DE66E770EA}"/>
              </a:ext>
            </a:extLst>
          </p:cNvPr>
          <p:cNvSpPr txBox="1"/>
          <p:nvPr/>
        </p:nvSpPr>
        <p:spPr>
          <a:xfrm>
            <a:off x="78726" y="5151269"/>
            <a:ext cx="10883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Palatino Linotype" panose="02040502050505030304" pitchFamily="18" charset="0"/>
              </a:rPr>
              <a:t>Figure S1: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Palatino Linotype" panose="02040502050505030304" pitchFamily="18" charset="0"/>
              </a:rPr>
              <a:t>Number of detected chains (A) and their area percentage (B) of chains in our reference matrix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242742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, scatter chart&#10;&#10;Description automatically generated">
            <a:extLst>
              <a:ext uri="{FF2B5EF4-FFF2-40B4-BE49-F238E27FC236}">
                <a16:creationId xmlns:a16="http://schemas.microsoft.com/office/drawing/2014/main" id="{50C66FAA-76A0-4245-BE71-ADE7AC65937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582"/>
          <a:stretch/>
        </p:blipFill>
        <p:spPr>
          <a:xfrm>
            <a:off x="1544395" y="82081"/>
            <a:ext cx="4849565" cy="6406587"/>
          </a:xfrm>
          <a:prstGeom prst="rect">
            <a:avLst/>
          </a:prstGeom>
        </p:spPr>
      </p:pic>
      <p:pic>
        <p:nvPicPr>
          <p:cNvPr id="5" name="Picture 4" descr="Diagram&#10;&#10;Description automatically generated">
            <a:extLst>
              <a:ext uri="{FF2B5EF4-FFF2-40B4-BE49-F238E27FC236}">
                <a16:creationId xmlns:a16="http://schemas.microsoft.com/office/drawing/2014/main" id="{BA9FCC6F-870C-4BAF-95B6-354F168E7E0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582"/>
          <a:stretch/>
        </p:blipFill>
        <p:spPr>
          <a:xfrm>
            <a:off x="6393960" y="82081"/>
            <a:ext cx="4849565" cy="640658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754E768-8924-4C58-9E7C-42B2C7C0AE83}"/>
              </a:ext>
            </a:extLst>
          </p:cNvPr>
          <p:cNvSpPr txBox="1"/>
          <p:nvPr/>
        </p:nvSpPr>
        <p:spPr>
          <a:xfrm>
            <a:off x="401973" y="6319391"/>
            <a:ext cx="113880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Palatino Linotype" panose="02040502050505030304" pitchFamily="18" charset="0"/>
              </a:rPr>
              <a:t>Figure S2: </a:t>
            </a:r>
            <a:r>
              <a:rPr lang="en-US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Palatino Linotype" panose="02040502050505030304" pitchFamily="18" charset="0"/>
              </a:rPr>
              <a:t>Kendrick mass defect (KMD) plotted against lipid retention time to increase the confidence of lipid identification.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34065246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0FFC9052-6148-4402-BC6A-0FB592AC37B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187" y="1142983"/>
            <a:ext cx="3657627" cy="457203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B6F4870-B774-4128-9B63-D026C54A07E9}"/>
              </a:ext>
            </a:extLst>
          </p:cNvPr>
          <p:cNvSpPr txBox="1"/>
          <p:nvPr/>
        </p:nvSpPr>
        <p:spPr>
          <a:xfrm>
            <a:off x="3987570" y="5530350"/>
            <a:ext cx="42168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Palatino Linotype" panose="02040502050505030304" pitchFamily="18" charset="0"/>
              </a:rPr>
              <a:t>Figure S3: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Palatino Linotype" panose="02040502050505030304" pitchFamily="18" charset="0"/>
              </a:rPr>
              <a:t>Validation of the PLS model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067976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55</Words>
  <Application>Microsoft Office PowerPoint</Application>
  <PresentationFormat>Widescreen</PresentationFormat>
  <Paragraphs>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men Škrab</dc:creator>
  <cp:lastModifiedBy>Domen Škrab</cp:lastModifiedBy>
  <cp:revision>1</cp:revision>
  <dcterms:created xsi:type="dcterms:W3CDTF">2021-11-17T19:24:53Z</dcterms:created>
  <dcterms:modified xsi:type="dcterms:W3CDTF">2021-11-17T19:43:05Z</dcterms:modified>
</cp:coreProperties>
</file>